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690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2542D-7C69-4C1B-AD4B-2781E1362EDB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921AD9-7B80-4ADA-B320-1DA05726B9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85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Updated points in PLs for date sold (two were missing in the earlier version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DB3FFA-3AD9-4FEB-8A03-5A612FF74AD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61662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913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13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784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882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378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96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8547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082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974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001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242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8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 rot="16200000">
            <a:off x="-4480250" y="785002"/>
            <a:ext cx="10515600" cy="1325563"/>
          </a:xfrm>
        </p:spPr>
        <p:txBody>
          <a:bodyPr/>
          <a:lstStyle/>
          <a:p>
            <a:r>
              <a:rPr lang="en-GB" dirty="0"/>
              <a:t>Fig S5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B84EE65-ADD0-4FD9-8D65-96C5926C3616}"/>
              </a:ext>
            </a:extLst>
          </p:cNvPr>
          <p:cNvGrpSpPr>
            <a:grpSpLocks noChangeAspect="1"/>
          </p:cNvGrpSpPr>
          <p:nvPr/>
        </p:nvGrpSpPr>
        <p:grpSpPr>
          <a:xfrm>
            <a:off x="2316024" y="855837"/>
            <a:ext cx="5738754" cy="5622370"/>
            <a:chOff x="100705" y="76720"/>
            <a:chExt cx="9842844" cy="964322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0682FCC-2983-4278-87A9-DF87DF45837B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705" y="76720"/>
              <a:ext cx="3228975" cy="319659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8844628-746E-4C93-9A5E-FA8F12EC1435}"/>
                </a:ext>
              </a:extLst>
            </p:cNvPr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39072" y="82117"/>
              <a:ext cx="3185795" cy="318579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DC4B4DD-04DA-48A4-AD68-34AD55EBC5B2}"/>
                </a:ext>
              </a:extLst>
            </p:cNvPr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34259" y="76720"/>
              <a:ext cx="3207385" cy="320738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BCD0393-FE78-43CB-80F4-367CF35D374A}"/>
                </a:ext>
              </a:extLst>
            </p:cNvPr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705" y="3284105"/>
              <a:ext cx="3239770" cy="321818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227F2B1-B130-4DA7-BB9F-08BAEE0D3106}"/>
                </a:ext>
              </a:extLst>
            </p:cNvPr>
            <p:cNvPicPr/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13672" y="3292995"/>
              <a:ext cx="3211195" cy="32004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EE9928AA-5D5A-47B2-AD1C-6B1242FF67C9}"/>
                </a:ext>
              </a:extLst>
            </p:cNvPr>
            <p:cNvPicPr/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34259" y="3267912"/>
              <a:ext cx="3200400" cy="322199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FB45F16-A615-4AEA-9B79-33DEEE2E7666}"/>
                </a:ext>
              </a:extLst>
            </p:cNvPr>
            <p:cNvPicPr/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705" y="6487162"/>
              <a:ext cx="3257550" cy="323278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611AB73-5070-4850-9539-DABB77A2389B}"/>
                </a:ext>
              </a:extLst>
            </p:cNvPr>
            <p:cNvPicPr/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25369" y="6487162"/>
              <a:ext cx="3218180" cy="319659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105EBC2C-E813-4C8D-8D51-4E731EA478AA}"/>
              </a:ext>
            </a:extLst>
          </p:cNvPr>
          <p:cNvSpPr txBox="1"/>
          <p:nvPr/>
        </p:nvSpPr>
        <p:spPr>
          <a:xfrm>
            <a:off x="2752707" y="514074"/>
            <a:ext cx="5163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egoe UI Semibold" panose="020B0702040204020203" pitchFamily="34" charset="0"/>
                <a:cs typeface="Segoe UI Semibold" panose="020B0702040204020203" pitchFamily="34" charset="0"/>
              </a:rPr>
              <a:t>Glycerides          Phospholipids          Fatty Acids</a:t>
            </a:r>
            <a:endParaRPr lang="en-GB" dirty="0">
              <a:latin typeface="Segoe UI Semibold" panose="020B0702040204020203" pitchFamily="34" charset="0"/>
              <a:cs typeface="Segoe UI Semibold" panose="020B0702040204020203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A786ADF-6A25-4C93-A277-6F583DF420D0}"/>
              </a:ext>
            </a:extLst>
          </p:cNvPr>
          <p:cNvSpPr txBox="1"/>
          <p:nvPr/>
        </p:nvSpPr>
        <p:spPr>
          <a:xfrm rot="16200000">
            <a:off x="-505968" y="3270112"/>
            <a:ext cx="5142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Segoe UI Semibold" panose="020B0702040204020203" pitchFamily="34" charset="0"/>
                <a:cs typeface="Segoe UI Semibold" panose="020B0702040204020203" pitchFamily="34" charset="0"/>
              </a:rPr>
              <a:t>Date sold                  Type                     Brand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550106A-C80A-428F-9482-589C1BE72628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5300" y="4519766"/>
            <a:ext cx="2010942" cy="201094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8857481" y="883405"/>
            <a:ext cx="2281574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Fig. S5.  PCAs of the British formula (UKB1-4) representing glyceride (left column), lipid (middle column) and fatty acid (right column) profiles.  Samples are grouped according to Brand (top row), Target demographic (middle row), and Date soled (bottom row).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304510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2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Gentium Basic</vt:lpstr>
      <vt:lpstr>Segoe UI Semibold</vt:lpstr>
      <vt:lpstr>Times New Roman</vt:lpstr>
      <vt:lpstr>Office Theme</vt:lpstr>
      <vt:lpstr>Fig S5</vt:lpstr>
    </vt:vector>
  </TitlesOfParts>
  <Company>Clinical School Computing Servi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</dc:title>
  <dc:creator>Samuel Furse</dc:creator>
  <cp:lastModifiedBy>Samuel Furse</cp:lastModifiedBy>
  <cp:revision>11</cp:revision>
  <dcterms:created xsi:type="dcterms:W3CDTF">2019-04-10T14:00:46Z</dcterms:created>
  <dcterms:modified xsi:type="dcterms:W3CDTF">2019-04-29T07:50:18Z</dcterms:modified>
</cp:coreProperties>
</file>